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3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eem Al Jayyousi" userId="da9e314d-c1a3-49f0-8976-e1062e1a0160" providerId="ADAL" clId="{2D54E1E0-9ED9-4B3C-9E2A-7BADE487BD00}"/>
    <pc:docChg chg="delSld">
      <pc:chgData name="Reem Al Jayyousi" userId="da9e314d-c1a3-49f0-8976-e1062e1a0160" providerId="ADAL" clId="{2D54E1E0-9ED9-4B3C-9E2A-7BADE487BD00}" dt="2025-03-23T22:38:28.500" v="0" actId="47"/>
      <pc:docMkLst>
        <pc:docMk/>
      </pc:docMkLst>
      <pc:sldChg chg="del">
        <pc:chgData name="Reem Al Jayyousi" userId="da9e314d-c1a3-49f0-8976-e1062e1a0160" providerId="ADAL" clId="{2D54E1E0-9ED9-4B3C-9E2A-7BADE487BD00}" dt="2025-03-23T22:38:28.500" v="0" actId="47"/>
        <pc:sldMkLst>
          <pc:docMk/>
          <pc:sldMk cId="2970186948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3635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744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58736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6403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7135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4271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0557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5385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768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90275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1747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A5AEA-F743-4D20-A212-8426D6CF1754}" type="datetimeFigureOut">
              <a:rPr lang="en-GB" smtClean="0"/>
              <a:t>24/03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68F11D-CDDB-4E1E-81DF-11DFFAC22D2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3218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E6335DE-FBEC-70E3-1DAB-4DDC4A0783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2777743"/>
              </p:ext>
            </p:extLst>
          </p:nvPr>
        </p:nvGraphicFramePr>
        <p:xfrm>
          <a:off x="127001" y="211668"/>
          <a:ext cx="12005727" cy="6264880"/>
        </p:xfrm>
        <a:graphic>
          <a:graphicData uri="http://schemas.openxmlformats.org/drawingml/2006/table">
            <a:tbl>
              <a:tblPr/>
              <a:tblGrid>
                <a:gridCol w="2282680">
                  <a:extLst>
                    <a:ext uri="{9D8B030D-6E8A-4147-A177-3AD203B41FA5}">
                      <a16:colId xmlns:a16="http://schemas.microsoft.com/office/drawing/2014/main" val="2696791868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1945781137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95406514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518107454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105301214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1246323462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4232522512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785687831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741293032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131755521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599529739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768235605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1141794741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50120203"/>
                    </a:ext>
                  </a:extLst>
                </a:gridCol>
                <a:gridCol w="426197">
                  <a:extLst>
                    <a:ext uri="{9D8B030D-6E8A-4147-A177-3AD203B41FA5}">
                      <a16:colId xmlns:a16="http://schemas.microsoft.com/office/drawing/2014/main" val="469045644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403043721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255020319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167616966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36650251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1623734496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939381729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364503409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348135990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383268505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3018224807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2817200589"/>
                    </a:ext>
                  </a:extLst>
                </a:gridCol>
                <a:gridCol w="397302">
                  <a:extLst>
                    <a:ext uri="{9D8B030D-6E8A-4147-A177-3AD203B41FA5}">
                      <a16:colId xmlns:a16="http://schemas.microsoft.com/office/drawing/2014/main" val="3211292678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924796162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990801626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695923133"/>
                    </a:ext>
                  </a:extLst>
                </a:gridCol>
                <a:gridCol w="317841">
                  <a:extLst>
                    <a:ext uri="{9D8B030D-6E8A-4147-A177-3AD203B41FA5}">
                      <a16:colId xmlns:a16="http://schemas.microsoft.com/office/drawing/2014/main" val="868702154"/>
                    </a:ext>
                  </a:extLst>
                </a:gridCol>
              </a:tblGrid>
              <a:tr h="175618">
                <a:tc gridSpan="31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Grant Reference MBRU-CM-RG2023-07 Investigating the role of co-enzyme A restriction in the pathophysiology of pre-eclampsia</a:t>
                      </a:r>
                    </a:p>
                  </a:txBody>
                  <a:tcPr marL="4128" marR="4128" marT="4128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A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17983533"/>
                  </a:ext>
                </a:extLst>
              </a:tr>
              <a:tr h="3466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Task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Sep (23)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Sep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Oct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Nov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Dec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an(24)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Feb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Mar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April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May 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un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ul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Aug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Sep(24)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Oct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Nov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Dec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an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Feb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Mar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April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May 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un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ul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Aug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Sep (25)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Oct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Nov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Dec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Jan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154624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Investigators meeting 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32872906"/>
                  </a:ext>
                </a:extLst>
              </a:tr>
              <a:tr h="697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Physician Workflow chart- protocol, consent , protocol, checklist, patient file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38857"/>
                  </a:ext>
                </a:extLst>
              </a:tr>
              <a:tr h="69775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Applying for and obtain research ethics approval include volunteer samples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 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4569496"/>
                  </a:ext>
                </a:extLst>
              </a:tr>
              <a:tr h="46917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Generating a list of consumables to be purchased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5471128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Purchase reagents for experiments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0611108"/>
                  </a:ext>
                </a:extLst>
              </a:tr>
              <a:tr h="3989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Purchase other consumables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8030362"/>
                  </a:ext>
                </a:extLst>
              </a:tr>
              <a:tr h="39995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Liaise with HR about the appointment of a research assistant (RA).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 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0688093"/>
                  </a:ext>
                </a:extLst>
              </a:tr>
              <a:tr h="46917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Research assistant starts and onboarding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2281158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Optimise lab meaurements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05496873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Conduct experiments- Objective 1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1477313"/>
                  </a:ext>
                </a:extLst>
              </a:tr>
              <a:tr h="46917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Patient recruitment and sample collection- objective 2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0812849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Cell Culture work- Objective 3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4246279"/>
                  </a:ext>
                </a:extLst>
              </a:tr>
              <a:tr h="2706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Data analysis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E" sz="1000" b="0" i="0" u="none" strike="noStrike">
                        <a:solidFill>
                          <a:srgbClr val="000000"/>
                        </a:solidFill>
                        <a:effectLst/>
                        <a:latin typeface="Dubai" panose="020B0503030403030204" pitchFamily="34" charset="-78"/>
                        <a:cs typeface="Dubai" panose="020B0503030403030204" pitchFamily="34" charset="-78"/>
                      </a:endParaRP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AE" sz="1000" b="0" i="0" u="none" strike="noStrike">
                        <a:solidFill>
                          <a:srgbClr val="000000"/>
                        </a:solidFill>
                        <a:effectLst/>
                        <a:latin typeface="Dubai" panose="020B0503030403030204" pitchFamily="34" charset="-78"/>
                        <a:cs typeface="Dubai" panose="020B0503030403030204" pitchFamily="34" charset="-78"/>
                      </a:endParaRPr>
                    </a:p>
                  </a:txBody>
                  <a:tcPr marL="4128" marR="4128" marT="4128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1958380"/>
                  </a:ext>
                </a:extLst>
              </a:tr>
              <a:tr h="26466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Writing up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9204958"/>
                  </a:ext>
                </a:extLst>
              </a:tr>
              <a:tr h="2706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Dissemination of results.</a:t>
                      </a:r>
                    </a:p>
                  </a:txBody>
                  <a:tcPr marL="4128" marR="4128" marT="4128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AE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 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Dubai" panose="020B0503030403030204" pitchFamily="34" charset="-78"/>
                          <a:cs typeface="Dubai" panose="020B0503030403030204" pitchFamily="34" charset="-78"/>
                        </a:rPr>
                        <a:t>x</a:t>
                      </a:r>
                    </a:p>
                  </a:txBody>
                  <a:tcPr marL="4128" marR="4128" marT="412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26922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02092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Custom 1">
      <a:majorFont>
        <a:latin typeface="Dubai"/>
        <a:ea typeface=""/>
        <a:cs typeface="Dubai"/>
      </a:majorFont>
      <a:minorFont>
        <a:latin typeface="Dubai"/>
        <a:ea typeface=""/>
        <a:cs typeface="Dubai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75EE2659-DB80-4DF1-BD3D-4B3D72DD26B9}" vid="{88B50951-EFFF-4C19-B5F4-BD5F43C037C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</TotalTime>
  <Words>594</Words>
  <Application>Microsoft Office PowerPoint</Application>
  <PresentationFormat>Widescreen</PresentationFormat>
  <Paragraphs>4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Duba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eem Al Jayyousi</dc:creator>
  <cp:lastModifiedBy>Reem Al Jayyousi</cp:lastModifiedBy>
  <cp:revision>1</cp:revision>
  <dcterms:created xsi:type="dcterms:W3CDTF">2025-03-23T22:35:49Z</dcterms:created>
  <dcterms:modified xsi:type="dcterms:W3CDTF">2025-03-23T22:38:31Z</dcterms:modified>
</cp:coreProperties>
</file>